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2" d="100"/>
          <a:sy n="112" d="100"/>
        </p:scale>
        <p:origin x="-1632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0CC01A-C4D0-42FE-B74E-4EA93A11B229}" type="datetimeFigureOut">
              <a:rPr lang="en-GB" smtClean="0"/>
              <a:t>13/12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E1A27F-1E20-482F-ABA0-4E3F50D00B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88645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0CC01A-C4D0-42FE-B74E-4EA93A11B229}" type="datetimeFigureOut">
              <a:rPr lang="en-GB" smtClean="0"/>
              <a:t>13/12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E1A27F-1E20-482F-ABA0-4E3F50D00B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75223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0CC01A-C4D0-42FE-B74E-4EA93A11B229}" type="datetimeFigureOut">
              <a:rPr lang="en-GB" smtClean="0"/>
              <a:t>13/12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E1A27F-1E20-482F-ABA0-4E3F50D00B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91654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0CC01A-C4D0-42FE-B74E-4EA93A11B229}" type="datetimeFigureOut">
              <a:rPr lang="en-GB" smtClean="0"/>
              <a:t>13/12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E1A27F-1E20-482F-ABA0-4E3F50D00B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59581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0CC01A-C4D0-42FE-B74E-4EA93A11B229}" type="datetimeFigureOut">
              <a:rPr lang="en-GB" smtClean="0"/>
              <a:t>13/12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E1A27F-1E20-482F-ABA0-4E3F50D00B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77191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0CC01A-C4D0-42FE-B74E-4EA93A11B229}" type="datetimeFigureOut">
              <a:rPr lang="en-GB" smtClean="0"/>
              <a:t>13/12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E1A27F-1E20-482F-ABA0-4E3F50D00B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72911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0CC01A-C4D0-42FE-B74E-4EA93A11B229}" type="datetimeFigureOut">
              <a:rPr lang="en-GB" smtClean="0"/>
              <a:t>13/12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E1A27F-1E20-482F-ABA0-4E3F50D00B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571035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0CC01A-C4D0-42FE-B74E-4EA93A11B229}" type="datetimeFigureOut">
              <a:rPr lang="en-GB" smtClean="0"/>
              <a:t>13/12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E1A27F-1E20-482F-ABA0-4E3F50D00B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686391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0CC01A-C4D0-42FE-B74E-4EA93A11B229}" type="datetimeFigureOut">
              <a:rPr lang="en-GB" smtClean="0"/>
              <a:t>13/12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E1A27F-1E20-482F-ABA0-4E3F50D00B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768957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0CC01A-C4D0-42FE-B74E-4EA93A11B229}" type="datetimeFigureOut">
              <a:rPr lang="en-GB" smtClean="0"/>
              <a:t>13/12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E1A27F-1E20-482F-ABA0-4E3F50D00B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7186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0CC01A-C4D0-42FE-B74E-4EA93A11B229}" type="datetimeFigureOut">
              <a:rPr lang="en-GB" smtClean="0"/>
              <a:t>13/12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E1A27F-1E20-482F-ABA0-4E3F50D00B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727276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0CC01A-C4D0-42FE-B74E-4EA93A11B229}" type="datetimeFigureOut">
              <a:rPr lang="en-GB" smtClean="0"/>
              <a:t>13/12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E1A27F-1E20-482F-ABA0-4E3F50D00B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088624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2589169" y="3285759"/>
            <a:ext cx="1147174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n-GB" sz="1600" b="1" dirty="0" smtClean="0"/>
              <a:t>B) WOMEN</a:t>
            </a:r>
            <a:endParaRPr lang="en-GB" sz="1600" dirty="0"/>
          </a:p>
        </p:txBody>
      </p:sp>
      <p:graphicFrame>
        <p:nvGraphicFramePr>
          <p:cNvPr id="8" name="Tab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41676775"/>
              </p:ext>
            </p:extLst>
          </p:nvPr>
        </p:nvGraphicFramePr>
        <p:xfrm>
          <a:off x="755577" y="13230"/>
          <a:ext cx="7848872" cy="157198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7376092"/>
                <a:gridCol w="472780"/>
              </a:tblGrid>
              <a:tr h="157372">
                <a:tc gridSpan="2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smtClean="0">
                          <a:solidFill>
                            <a:schemeClr val="tx1"/>
                          </a:solidFill>
                          <a:effectLst/>
                        </a:rPr>
                        <a:t>Appendix figure </a:t>
                      </a:r>
                      <a:r>
                        <a:rPr lang="en-GB" sz="1100" dirty="0">
                          <a:solidFill>
                            <a:schemeClr val="tx1"/>
                          </a:solidFill>
                          <a:effectLst/>
                        </a:rPr>
                        <a:t>1: Distribution of salivary testosterone in men (A) and women (B) in the general population with exclusions*</a:t>
                      </a:r>
                      <a:endParaRPr lang="en-GB" sz="11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503592">
                <a:tc gridSpan="2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chemeClr val="tx1"/>
                          </a:solidFill>
                          <a:effectLst/>
                        </a:rPr>
                        <a:t>Curves created using </a:t>
                      </a:r>
                      <a:r>
                        <a:rPr lang="en-GB" sz="1100" u="sng" dirty="0">
                          <a:solidFill>
                            <a:schemeClr val="tx1"/>
                          </a:solidFill>
                          <a:effectLst/>
                        </a:rPr>
                        <a:t>linear regression (solid line</a:t>
                      </a:r>
                      <a:r>
                        <a:rPr lang="en-GB" sz="1100" dirty="0">
                          <a:solidFill>
                            <a:schemeClr val="tx1"/>
                          </a:solidFill>
                          <a:effectLst/>
                        </a:rPr>
                        <a:t>) for the fitted mean (men) or geometric mean (women), 2.5th and 97.5th percentiles, and </a:t>
                      </a:r>
                      <a:r>
                        <a:rPr lang="en-GB" sz="1100" u="sng" dirty="0">
                          <a:solidFill>
                            <a:schemeClr val="tx1"/>
                          </a:solidFill>
                          <a:effectLst/>
                        </a:rPr>
                        <a:t>quantile regression (dashed line</a:t>
                      </a:r>
                      <a:r>
                        <a:rPr lang="en-GB" sz="1100" dirty="0">
                          <a:solidFill>
                            <a:schemeClr val="tx1"/>
                          </a:solidFill>
                          <a:effectLst/>
                        </a:rPr>
                        <a:t>) for the median, 2.5th percentile and 97.5th percentile.</a:t>
                      </a:r>
                      <a:endParaRPr lang="en-GB" sz="11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88259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chemeClr val="tx1"/>
                          </a:solidFill>
                          <a:effectLst/>
                        </a:rPr>
                        <a:t>Observed values (x) of 1074 men and 1276 women are displayed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chemeClr val="tx1"/>
                          </a:solidFill>
                          <a:effectLst/>
                        </a:rPr>
                        <a:t>* Men with a body mass index (BMI) &lt;18.5 or &gt;30 kg/m</a:t>
                      </a:r>
                      <a:r>
                        <a:rPr lang="en-GB" sz="1100" baseline="30000" dirty="0"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r>
                        <a:rPr lang="en-GB" sz="1100" dirty="0">
                          <a:solidFill>
                            <a:schemeClr val="tx1"/>
                          </a:solidFill>
                          <a:effectLst/>
                        </a:rPr>
                        <a:t> and women with a BMI &lt;18.5 or &gt;40 kg/m</a:t>
                      </a:r>
                      <a:r>
                        <a:rPr lang="en-GB" sz="1100" baseline="30000" dirty="0"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r>
                        <a:rPr lang="en-GB" sz="1100" dirty="0">
                          <a:solidFill>
                            <a:schemeClr val="tx1"/>
                          </a:solidFill>
                          <a:effectLst/>
                        </a:rPr>
                        <a:t>;</a:t>
                      </a:r>
                      <a:r>
                        <a:rPr lang="en-GB" sz="1100" baseline="30000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GB" sz="1100" dirty="0">
                          <a:solidFill>
                            <a:schemeClr val="tx1"/>
                          </a:solidFill>
                          <a:effectLst/>
                        </a:rPr>
                        <a:t>prostate cancer, prostate enlargement, prostate surgery; polycystic ovaries; treatment for cancer, thyroid, testicular/ovarian or pituitary conditions in the past year; medication for epilepsy; women reporting both hysterectomy and HRT use; HRT; and hormonal contraception. All self-reported. See 'study population' section of methods for further details of exclusion criteria.</a:t>
                      </a:r>
                      <a:endParaRPr lang="en-GB" sz="11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>
                          <a:effectLst/>
                        </a:rPr>
                        <a:t> 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0" marR="0" marT="0" marB="0" anchor="ctr"/>
                </a:tc>
              </a:tr>
            </a:tbl>
          </a:graphicData>
        </a:graphic>
      </p:graphicFrame>
      <p:pic>
        <p:nvPicPr>
          <p:cNvPr id="2050" name="Picture 9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13049" y="1882934"/>
            <a:ext cx="3294917" cy="240096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49" name="Picture 10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51103" y="4452206"/>
            <a:ext cx="3223272" cy="234843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Rectangle 3"/>
          <p:cNvSpPr>
            <a:spLocks noChangeArrowheads="1"/>
          </p:cNvSpPr>
          <p:nvPr/>
        </p:nvSpPr>
        <p:spPr bwMode="auto">
          <a:xfrm>
            <a:off x="1689928" y="1633129"/>
            <a:ext cx="769085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tabLst/>
            </a:pPr>
            <a:r>
              <a:rPr kumimoji="0" lang="en-GB" altLang="en-US" sz="11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A) Men</a:t>
            </a:r>
            <a:endParaRPr kumimoji="0" lang="en-GB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Rectangle 4"/>
          <p:cNvSpPr>
            <a:spLocks noChangeArrowheads="1"/>
          </p:cNvSpPr>
          <p:nvPr/>
        </p:nvSpPr>
        <p:spPr bwMode="auto">
          <a:xfrm>
            <a:off x="1732350" y="4200981"/>
            <a:ext cx="889099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tabLst/>
            </a:pPr>
            <a:r>
              <a:rPr kumimoji="0" lang="en-GB" altLang="en-US" sz="11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B) Women</a:t>
            </a:r>
            <a:endParaRPr kumimoji="0" lang="en-GB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337583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7</TotalTime>
  <Words>181</Words>
  <Application>Microsoft Office PowerPoint</Application>
  <PresentationFormat>On-screen Show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HS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rian Keevil</dc:creator>
  <cp:lastModifiedBy>Brian Keevil</cp:lastModifiedBy>
  <cp:revision>6</cp:revision>
  <dcterms:created xsi:type="dcterms:W3CDTF">2016-12-08T16:42:10Z</dcterms:created>
  <dcterms:modified xsi:type="dcterms:W3CDTF">2016-12-13T09:10:09Z</dcterms:modified>
</cp:coreProperties>
</file>